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62"/>
    <p:restoredTop sz="94631"/>
  </p:normalViewPr>
  <p:slideViewPr>
    <p:cSldViewPr snapToGrid="0" snapToObjects="1">
      <p:cViewPr>
        <p:scale>
          <a:sx n="111" d="100"/>
          <a:sy n="111" d="100"/>
        </p:scale>
        <p:origin x="-3016" y="-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7F0D0D-744B-E34B-A11C-D6F4F09ABC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7106FE0-BA8E-A145-9EAE-32484566B2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8E54A5-0DD8-F644-A4EC-7E093ACC8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02FB8A-CD6B-7D45-83C8-3C38D05CD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D0FD22-6B2C-6B4C-9578-C1666027B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3004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F8A139-226E-5B4B-8B64-C6E73FD51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C67418B-FDF1-F546-80DA-AAB398D28D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16A9A5-487A-004D-A2A0-23FD48C8C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462650-0702-F742-AE4B-6FEDD35CA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926334-FC3C-264A-801B-9B10679C2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2819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4876104-B07C-EB47-8E15-78A2D6E0A9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4CEBE56-6311-9B43-BC3C-E4F953FDEF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82EF62B-C83B-D844-AD71-4094691B3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FC9F58B-B213-7147-8C06-C5D50543C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35D159-E126-314E-8315-5D75D5737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444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2DD039-7EF3-BC44-B266-3176BC4BBB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D3A7DE6-0AA4-4F40-A43D-79342C384F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D2D05A-ED55-6845-AB93-5AA705CA3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8FA28A-71D2-114A-A7EE-473340046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392646-E8CE-214B-A768-DFF4E5E70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096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D6126B-C5FD-A341-90A8-2C482266E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BB9F5D5-7A61-7F4B-AA1E-9E2ED0EF0E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1789929-84AD-8342-91FE-138AEABFD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846666E-6F1B-574C-8726-88E44B253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23978D3-F7EA-8547-88BE-33847054E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1376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3A77B9-7BDC-A343-A420-4730191362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4409E08-1ED0-784A-B8CF-B239CCB61C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15D0934-F4AA-DD4E-907F-5313442F4E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184E0C-A9E0-CE43-AE87-458FB2E83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DA7102-F986-0541-9DEC-1F3916DC4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E05A648-8C11-554E-BAB2-32330674E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1398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F8FDAE-6A08-484B-8538-7ED1993289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76EF457-B38E-0C42-A777-36EDF9436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1F3F89D-362D-BF49-8665-FFEE179498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80CC2E9-D2A9-0140-BF6C-793D01949E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C82069D-6EE4-8C47-A459-8CAA786EC5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4A11BC4-0472-8742-988E-EC8CEBAEC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AA20514-4687-414D-9A5E-836284C1B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022B654-B838-8246-8F46-A6B20A47B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648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9950BA-69F9-E445-AB3C-69B485354B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6BDA775-575B-664F-BE22-88D287786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38B48CA-0835-9441-8AC0-AA3224640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730596B-8280-1942-ABEF-FE4CCC62C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1037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6A02502-5FDC-FD48-BA1E-673251285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576F1D7-94A6-5948-AED4-BFC46ABC8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3564DDF-4184-8C43-BB16-81BEF6A92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163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4578C1-D9EC-724F-8DFE-F8CD1B4421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31B6F09-DAED-CD4F-B720-75D1D2812A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C1B6D42-7424-344B-8241-90DB33E77F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DA7C881-361D-C245-958A-B687F9694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032EFF0-6FA0-1941-9FB2-9187E8090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AAE75B5-9988-F94D-8F0F-BA115BF90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497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134664-A548-3645-8E8B-0D73A1E09B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AA42BCD-6DF7-904E-B21D-5881ADAEEF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395F5F3-05B8-0F43-B62E-8FF42FB3E1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A8F895-0AA5-174F-A473-3C4BDFD7D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D47DF81-E2B8-3343-BC88-BBB07B8C2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4E5065-36AD-8244-A973-267FD2B9C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9739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F223FBF-ABFE-2B4B-B813-E2E0D0ED5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1A710F8-CF83-084D-B943-F9146D81EF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12D2F0-83B6-3C49-9FE3-99B7712384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C6333-9849-F14B-B5E2-7F7102790494}" type="datetimeFigureOut">
              <a:rPr kumimoji="1" lang="ja-JP" altLang="en-US" smtClean="0"/>
              <a:t>2024/4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77CC82-B600-2F41-9443-4E7C701236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6E532C-E228-834C-A5CE-E21B10D072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2981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B186A88-39CB-4D47-9B8A-56BC7E4B0D3D}"/>
              </a:ext>
            </a:extLst>
          </p:cNvPr>
          <p:cNvSpPr txBox="1"/>
          <p:nvPr/>
        </p:nvSpPr>
        <p:spPr>
          <a:xfrm rot="16200000">
            <a:off x="2422033" y="588523"/>
            <a:ext cx="1338295" cy="338552"/>
          </a:xfrm>
          <a:prstGeom prst="rect">
            <a:avLst/>
          </a:prstGeom>
          <a:noFill/>
          <a:ln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95E34EC-230E-124B-A234-E02C161F0979}"/>
              </a:ext>
            </a:extLst>
          </p:cNvPr>
          <p:cNvSpPr txBox="1"/>
          <p:nvPr/>
        </p:nvSpPr>
        <p:spPr>
          <a:xfrm rot="16200000">
            <a:off x="2492654" y="2843109"/>
            <a:ext cx="1197050" cy="338554"/>
          </a:xfrm>
          <a:prstGeom prst="rect">
            <a:avLst/>
          </a:prstGeom>
          <a:noFill/>
          <a:ln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eening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95F15EC-0F00-B44B-8420-8678040C1094}"/>
              </a:ext>
            </a:extLst>
          </p:cNvPr>
          <p:cNvSpPr txBox="1"/>
          <p:nvPr/>
        </p:nvSpPr>
        <p:spPr>
          <a:xfrm rot="16200000">
            <a:off x="2498355" y="4450460"/>
            <a:ext cx="1185650" cy="338555"/>
          </a:xfrm>
          <a:prstGeom prst="rect">
            <a:avLst/>
          </a:prstGeom>
          <a:noFill/>
          <a:ln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igibility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268384D-BE16-F94C-A1B3-CBAADA2FBD97}"/>
              </a:ext>
            </a:extLst>
          </p:cNvPr>
          <p:cNvSpPr txBox="1"/>
          <p:nvPr/>
        </p:nvSpPr>
        <p:spPr>
          <a:xfrm rot="16200000">
            <a:off x="2535656" y="6133198"/>
            <a:ext cx="1111049" cy="338554"/>
          </a:xfrm>
          <a:prstGeom prst="rect">
            <a:avLst/>
          </a:prstGeom>
          <a:noFill/>
          <a:ln>
            <a:solidFill>
              <a:srgbClr val="7030A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FBCBF86-3D5A-C940-839F-9FEC37D2D8AE}"/>
              </a:ext>
            </a:extLst>
          </p:cNvPr>
          <p:cNvSpPr txBox="1"/>
          <p:nvPr/>
        </p:nvSpPr>
        <p:spPr>
          <a:xfrm>
            <a:off x="3360420" y="326913"/>
            <a:ext cx="281178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rds identified through database searching</a:t>
            </a:r>
          </a:p>
          <a:p>
            <a:pPr algn="ctr"/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322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53CADCE-5B02-5141-B55C-DB172518D080}"/>
              </a:ext>
            </a:extLst>
          </p:cNvPr>
          <p:cNvSpPr txBox="1"/>
          <p:nvPr/>
        </p:nvSpPr>
        <p:spPr>
          <a:xfrm>
            <a:off x="6658004" y="326913"/>
            <a:ext cx="31623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records identified through other sources</a:t>
            </a:r>
          </a:p>
          <a:p>
            <a:pPr algn="ctr"/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24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C3CD077-58BB-ED46-A242-48FEE9CE99C7}"/>
              </a:ext>
            </a:extLst>
          </p:cNvPr>
          <p:cNvSpPr txBox="1"/>
          <p:nvPr/>
        </p:nvSpPr>
        <p:spPr>
          <a:xfrm>
            <a:off x="5076854" y="1446865"/>
            <a:ext cx="31623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rds scanned by title and abstract </a:t>
            </a:r>
          </a:p>
          <a:p>
            <a:pPr algn="ctr"/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346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C44540C-D41A-0F42-9055-C0C47C376392}"/>
              </a:ext>
            </a:extLst>
          </p:cNvPr>
          <p:cNvSpPr txBox="1"/>
          <p:nvPr/>
        </p:nvSpPr>
        <p:spPr>
          <a:xfrm>
            <a:off x="8494508" y="2267664"/>
            <a:ext cx="26515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plicates removed, </a:t>
            </a:r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4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7E3548E-C9B7-FC4E-ACE5-8834CC82F5A6}"/>
              </a:ext>
            </a:extLst>
          </p:cNvPr>
          <p:cNvSpPr txBox="1"/>
          <p:nvPr/>
        </p:nvSpPr>
        <p:spPr>
          <a:xfrm>
            <a:off x="5076854" y="2630703"/>
            <a:ext cx="31623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rds scanned</a:t>
            </a:r>
          </a:p>
          <a:p>
            <a:pPr algn="ctr"/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342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27D9D70-EFB4-D649-B03C-F5EBF82B96BA}"/>
              </a:ext>
            </a:extLst>
          </p:cNvPr>
          <p:cNvSpPr txBox="1"/>
          <p:nvPr/>
        </p:nvSpPr>
        <p:spPr>
          <a:xfrm>
            <a:off x="8459036" y="3165090"/>
            <a:ext cx="27383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rds excluded, </a:t>
            </a:r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281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94D24A9-1935-EC45-928A-267ED38CC9DA}"/>
              </a:ext>
            </a:extLst>
          </p:cNvPr>
          <p:cNvSpPr txBox="1"/>
          <p:nvPr/>
        </p:nvSpPr>
        <p:spPr>
          <a:xfrm>
            <a:off x="5406448" y="3515010"/>
            <a:ext cx="2507889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-text articles assessed for eligibility</a:t>
            </a:r>
          </a:p>
          <a:p>
            <a:pPr algn="ctr"/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61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59FAF3A-6E9B-1E49-B60E-C1D30BBB4161}"/>
              </a:ext>
            </a:extLst>
          </p:cNvPr>
          <p:cNvSpPr txBox="1"/>
          <p:nvPr/>
        </p:nvSpPr>
        <p:spPr>
          <a:xfrm>
            <a:off x="5404059" y="4684358"/>
            <a:ext cx="250788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ies included in descriptive evaluation</a:t>
            </a:r>
          </a:p>
          <a:p>
            <a:pPr algn="ctr"/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26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410E4E9-33B7-DD4E-9A4E-CFADBE7D1D5B}"/>
              </a:ext>
            </a:extLst>
          </p:cNvPr>
          <p:cNvSpPr txBox="1"/>
          <p:nvPr/>
        </p:nvSpPr>
        <p:spPr>
          <a:xfrm>
            <a:off x="5241650" y="5858290"/>
            <a:ext cx="28327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ies included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descriptive evaluation</a:t>
            </a:r>
          </a:p>
          <a:p>
            <a:pPr algn="ctr"/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26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2E247DD-C277-4443-BD5A-49B531125838}"/>
              </a:ext>
            </a:extLst>
          </p:cNvPr>
          <p:cNvSpPr txBox="1"/>
          <p:nvPr/>
        </p:nvSpPr>
        <p:spPr>
          <a:xfrm>
            <a:off x="8459036" y="3954321"/>
            <a:ext cx="31623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-text articles excluded, </a:t>
            </a:r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35</a:t>
            </a:r>
          </a:p>
          <a:p>
            <a:r>
              <a:rPr kumimoji="1" lang="ja-JP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comparative studie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= 27</a:t>
            </a: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ja-JP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astatic setting </a:t>
            </a:r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6</a:t>
            </a:r>
          </a:p>
          <a:p>
            <a:r>
              <a:rPr lang="ja-JP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No outcomes n=2</a:t>
            </a: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90EF1745-9B4C-344A-8B86-A9FAAFE04967}"/>
              </a:ext>
            </a:extLst>
          </p:cNvPr>
          <p:cNvCxnSpPr>
            <a:stCxn id="11" idx="2"/>
            <a:endCxn id="13" idx="0"/>
          </p:cNvCxnSpPr>
          <p:nvPr/>
        </p:nvCxnSpPr>
        <p:spPr>
          <a:xfrm>
            <a:off x="6658004" y="2308639"/>
            <a:ext cx="0" cy="322064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68EFDF1F-F872-F346-8643-D0C847A6E3E7}"/>
              </a:ext>
            </a:extLst>
          </p:cNvPr>
          <p:cNvCxnSpPr>
            <a:cxnSpLocks/>
            <a:endCxn id="11" idx="0"/>
          </p:cNvCxnSpPr>
          <p:nvPr/>
        </p:nvCxnSpPr>
        <p:spPr>
          <a:xfrm>
            <a:off x="6658003" y="1014608"/>
            <a:ext cx="1" cy="432257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ED9884E7-C46B-3A40-A522-787CF0547FC3}"/>
              </a:ext>
            </a:extLst>
          </p:cNvPr>
          <p:cNvCxnSpPr>
            <a:cxnSpLocks/>
            <a:stCxn id="13" idx="2"/>
            <a:endCxn id="15" idx="0"/>
          </p:cNvCxnSpPr>
          <p:nvPr/>
        </p:nvCxnSpPr>
        <p:spPr>
          <a:xfrm>
            <a:off x="6658004" y="3215478"/>
            <a:ext cx="2389" cy="299532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4CCEBCA0-F45F-FC4F-B929-7B3AAA3A0FF5}"/>
              </a:ext>
            </a:extLst>
          </p:cNvPr>
          <p:cNvCxnSpPr>
            <a:cxnSpLocks/>
            <a:stCxn id="15" idx="2"/>
            <a:endCxn id="16" idx="0"/>
          </p:cNvCxnSpPr>
          <p:nvPr/>
        </p:nvCxnSpPr>
        <p:spPr>
          <a:xfrm flipH="1">
            <a:off x="6658004" y="4376784"/>
            <a:ext cx="2389" cy="307574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1E75C606-858F-5941-A28C-3D85B8A15836}"/>
              </a:ext>
            </a:extLst>
          </p:cNvPr>
          <p:cNvCxnSpPr>
            <a:cxnSpLocks/>
            <a:stCxn id="16" idx="2"/>
            <a:endCxn id="17" idx="0"/>
          </p:cNvCxnSpPr>
          <p:nvPr/>
        </p:nvCxnSpPr>
        <p:spPr>
          <a:xfrm flipH="1">
            <a:off x="6658003" y="5515355"/>
            <a:ext cx="1" cy="342935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2974B9CA-E4A0-3943-AD6F-0A879F9788BA}"/>
              </a:ext>
            </a:extLst>
          </p:cNvPr>
          <p:cNvCxnSpPr>
            <a:cxnSpLocks/>
            <a:endCxn id="12" idx="1"/>
          </p:cNvCxnSpPr>
          <p:nvPr/>
        </p:nvCxnSpPr>
        <p:spPr>
          <a:xfrm>
            <a:off x="6658003" y="2436941"/>
            <a:ext cx="1836505" cy="0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1F568114-AB7C-9143-B057-2CAFA736AF46}"/>
              </a:ext>
            </a:extLst>
          </p:cNvPr>
          <p:cNvCxnSpPr>
            <a:cxnSpLocks/>
            <a:endCxn id="14" idx="1"/>
          </p:cNvCxnSpPr>
          <p:nvPr/>
        </p:nvCxnSpPr>
        <p:spPr>
          <a:xfrm>
            <a:off x="6665886" y="3334367"/>
            <a:ext cx="1793150" cy="0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E45ABF82-60AE-A540-BDCF-6B003D04F09D}"/>
              </a:ext>
            </a:extLst>
          </p:cNvPr>
          <p:cNvCxnSpPr>
            <a:cxnSpLocks/>
            <a:endCxn id="18" idx="1"/>
          </p:cNvCxnSpPr>
          <p:nvPr/>
        </p:nvCxnSpPr>
        <p:spPr>
          <a:xfrm flipV="1">
            <a:off x="6665886" y="4492930"/>
            <a:ext cx="1793150" cy="0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16082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4</TotalTime>
  <Words>100</Words>
  <Application>Microsoft Macintosh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Endo, Yutaka</cp:lastModifiedBy>
  <cp:revision>24</cp:revision>
  <dcterms:created xsi:type="dcterms:W3CDTF">2021-04-06T08:46:24Z</dcterms:created>
  <dcterms:modified xsi:type="dcterms:W3CDTF">2024-04-17T20:49:37Z</dcterms:modified>
</cp:coreProperties>
</file>